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0" r:id="rId2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40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7F7F"/>
    <a:srgbClr val="66FF66"/>
    <a:srgbClr val="E67DFF"/>
    <a:srgbClr val="FF66CC"/>
    <a:srgbClr val="CC00FF"/>
    <a:srgbClr val="00B0F0"/>
    <a:srgbClr val="808080"/>
    <a:srgbClr val="FF0000"/>
    <a:srgbClr val="2F75B5"/>
    <a:srgbClr val="95BEE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273" autoAdjust="0"/>
    <p:restoredTop sz="95366" autoAdjust="0"/>
  </p:normalViewPr>
  <p:slideViewPr>
    <p:cSldViewPr snapToGrid="0">
      <p:cViewPr varScale="1">
        <p:scale>
          <a:sx n="68" d="100"/>
          <a:sy n="68" d="100"/>
        </p:scale>
        <p:origin x="416" y="48"/>
      </p:cViewPr>
      <p:guideLst>
        <p:guide pos="3840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 m" userId="d8569de3593ce71f" providerId="LiveId" clId="{FAA8FB54-2119-49D6-996C-C9AF9F3138C2}"/>
    <pc:docChg chg="custSel addSld delSld modSld delMainMaster">
      <pc:chgData name="m m" userId="d8569de3593ce71f" providerId="LiveId" clId="{FAA8FB54-2119-49D6-996C-C9AF9F3138C2}" dt="2017-09-10T08:34:27.857" v="14" actId="2696"/>
      <pc:docMkLst>
        <pc:docMk/>
      </pc:docMkLst>
      <pc:sldChg chg="delSp del">
        <pc:chgData name="m m" userId="d8569de3593ce71f" providerId="LiveId" clId="{FAA8FB54-2119-49D6-996C-C9AF9F3138C2}" dt="2017-09-10T08:34:27.713" v="2" actId="2696"/>
        <pc:sldMkLst>
          <pc:docMk/>
          <pc:sldMk cId="3773084472" sldId="259"/>
        </pc:sldMkLst>
        <pc:graphicFrameChg chg="del">
          <ac:chgData name="m m" userId="d8569de3593ce71f" providerId="LiveId" clId="{FAA8FB54-2119-49D6-996C-C9AF9F3138C2}" dt="2017-09-10T08:34:18.550" v="0" actId="478"/>
          <ac:graphicFrameMkLst>
            <pc:docMk/>
            <pc:sldMk cId="3773084472" sldId="259"/>
            <ac:graphicFrameMk id="6" creationId="{00000000-0000-0000-0000-000000000000}"/>
          </ac:graphicFrameMkLst>
        </pc:graphicFrameChg>
      </pc:sldChg>
      <pc:sldChg chg="add">
        <pc:chgData name="m m" userId="d8569de3593ce71f" providerId="LiveId" clId="{FAA8FB54-2119-49D6-996C-C9AF9F3138C2}" dt="2017-09-10T08:34:22.837" v="1"/>
        <pc:sldMkLst>
          <pc:docMk/>
          <pc:sldMk cId="3608717038" sldId="260"/>
        </pc:sldMkLst>
      </pc:sldChg>
      <pc:sldMasterChg chg="del delSldLayout">
        <pc:chgData name="m m" userId="d8569de3593ce71f" providerId="LiveId" clId="{FAA8FB54-2119-49D6-996C-C9AF9F3138C2}" dt="2017-09-10T08:34:27.857" v="14" actId="2696"/>
        <pc:sldMasterMkLst>
          <pc:docMk/>
          <pc:sldMasterMk cId="1566704022" sldId="2147483648"/>
        </pc:sldMasterMkLst>
        <pc:sldLayoutChg chg="del">
          <pc:chgData name="m m" userId="d8569de3593ce71f" providerId="LiveId" clId="{FAA8FB54-2119-49D6-996C-C9AF9F3138C2}" dt="2017-09-10T08:34:27.721" v="3" actId="2696"/>
          <pc:sldLayoutMkLst>
            <pc:docMk/>
            <pc:sldMasterMk cId="1566704022" sldId="2147483648"/>
            <pc:sldLayoutMk cId="804836971" sldId="2147483649"/>
          </pc:sldLayoutMkLst>
        </pc:sldLayoutChg>
        <pc:sldLayoutChg chg="del">
          <pc:chgData name="m m" userId="d8569de3593ce71f" providerId="LiveId" clId="{FAA8FB54-2119-49D6-996C-C9AF9F3138C2}" dt="2017-09-10T08:34:27.737" v="4" actId="2696"/>
          <pc:sldLayoutMkLst>
            <pc:docMk/>
            <pc:sldMasterMk cId="1566704022" sldId="2147483648"/>
            <pc:sldLayoutMk cId="3810927218" sldId="2147483650"/>
          </pc:sldLayoutMkLst>
        </pc:sldLayoutChg>
        <pc:sldLayoutChg chg="del">
          <pc:chgData name="m m" userId="d8569de3593ce71f" providerId="LiveId" clId="{FAA8FB54-2119-49D6-996C-C9AF9F3138C2}" dt="2017-09-10T08:34:27.745" v="5" actId="2696"/>
          <pc:sldLayoutMkLst>
            <pc:docMk/>
            <pc:sldMasterMk cId="1566704022" sldId="2147483648"/>
            <pc:sldLayoutMk cId="993016680" sldId="2147483651"/>
          </pc:sldLayoutMkLst>
        </pc:sldLayoutChg>
        <pc:sldLayoutChg chg="del">
          <pc:chgData name="m m" userId="d8569de3593ce71f" providerId="LiveId" clId="{FAA8FB54-2119-49D6-996C-C9AF9F3138C2}" dt="2017-09-10T08:34:27.769" v="6" actId="2696"/>
          <pc:sldLayoutMkLst>
            <pc:docMk/>
            <pc:sldMasterMk cId="1566704022" sldId="2147483648"/>
            <pc:sldLayoutMk cId="970867603" sldId="2147483652"/>
          </pc:sldLayoutMkLst>
        </pc:sldLayoutChg>
        <pc:sldLayoutChg chg="del">
          <pc:chgData name="m m" userId="d8569de3593ce71f" providerId="LiveId" clId="{FAA8FB54-2119-49D6-996C-C9AF9F3138C2}" dt="2017-09-10T08:34:27.781" v="7" actId="2696"/>
          <pc:sldLayoutMkLst>
            <pc:docMk/>
            <pc:sldMasterMk cId="1566704022" sldId="2147483648"/>
            <pc:sldLayoutMk cId="1476136439" sldId="2147483653"/>
          </pc:sldLayoutMkLst>
        </pc:sldLayoutChg>
        <pc:sldLayoutChg chg="del">
          <pc:chgData name="m m" userId="d8569de3593ce71f" providerId="LiveId" clId="{FAA8FB54-2119-49D6-996C-C9AF9F3138C2}" dt="2017-09-10T08:34:27.789" v="8" actId="2696"/>
          <pc:sldLayoutMkLst>
            <pc:docMk/>
            <pc:sldMasterMk cId="1566704022" sldId="2147483648"/>
            <pc:sldLayoutMk cId="1924247715" sldId="2147483654"/>
          </pc:sldLayoutMkLst>
        </pc:sldLayoutChg>
        <pc:sldLayoutChg chg="del">
          <pc:chgData name="m m" userId="d8569de3593ce71f" providerId="LiveId" clId="{FAA8FB54-2119-49D6-996C-C9AF9F3138C2}" dt="2017-09-10T08:34:27.797" v="9" actId="2696"/>
          <pc:sldLayoutMkLst>
            <pc:docMk/>
            <pc:sldMasterMk cId="1566704022" sldId="2147483648"/>
            <pc:sldLayoutMk cId="3447044406" sldId="2147483655"/>
          </pc:sldLayoutMkLst>
        </pc:sldLayoutChg>
        <pc:sldLayoutChg chg="del">
          <pc:chgData name="m m" userId="d8569de3593ce71f" providerId="LiveId" clId="{FAA8FB54-2119-49D6-996C-C9AF9F3138C2}" dt="2017-09-10T08:34:27.809" v="10" actId="2696"/>
          <pc:sldLayoutMkLst>
            <pc:docMk/>
            <pc:sldMasterMk cId="1566704022" sldId="2147483648"/>
            <pc:sldLayoutMk cId="951148090" sldId="2147483656"/>
          </pc:sldLayoutMkLst>
        </pc:sldLayoutChg>
        <pc:sldLayoutChg chg="del">
          <pc:chgData name="m m" userId="d8569de3593ce71f" providerId="LiveId" clId="{FAA8FB54-2119-49D6-996C-C9AF9F3138C2}" dt="2017-09-10T08:34:27.817" v="11" actId="2696"/>
          <pc:sldLayoutMkLst>
            <pc:docMk/>
            <pc:sldMasterMk cId="1566704022" sldId="2147483648"/>
            <pc:sldLayoutMk cId="2053084797" sldId="2147483657"/>
          </pc:sldLayoutMkLst>
        </pc:sldLayoutChg>
        <pc:sldLayoutChg chg="del">
          <pc:chgData name="m m" userId="d8569de3593ce71f" providerId="LiveId" clId="{FAA8FB54-2119-49D6-996C-C9AF9F3138C2}" dt="2017-09-10T08:34:27.825" v="12" actId="2696"/>
          <pc:sldLayoutMkLst>
            <pc:docMk/>
            <pc:sldMasterMk cId="1566704022" sldId="2147483648"/>
            <pc:sldLayoutMk cId="2902520431" sldId="2147483658"/>
          </pc:sldLayoutMkLst>
        </pc:sldLayoutChg>
        <pc:sldLayoutChg chg="del">
          <pc:chgData name="m m" userId="d8569de3593ce71f" providerId="LiveId" clId="{FAA8FB54-2119-49D6-996C-C9AF9F3138C2}" dt="2017-09-10T08:34:27.833" v="13" actId="2696"/>
          <pc:sldLayoutMkLst>
            <pc:docMk/>
            <pc:sldMasterMk cId="1566704022" sldId="2147483648"/>
            <pc:sldLayoutMk cId="1798573445" sldId="2147483659"/>
          </pc:sldLayoutMkLst>
        </pc:sldLayoutChg>
      </pc:sldMaster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49267F-324A-4B06-A089-89A023B34E49}" type="datetimeFigureOut">
              <a:rPr lang="en-GB" smtClean="0"/>
              <a:t>10/09/2017</a:t>
            </a:fld>
            <a:endParaRPr lang="en-GB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324698-E344-41F0-A79C-87C0F1D8D03E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938775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F1D446-33F0-4FAA-A973-0B6A4C82719F}" type="datetimeFigureOut">
              <a:rPr lang="en-GB" smtClean="0"/>
              <a:t>10/09/2017</a:t>
            </a:fld>
            <a:endParaRPr lang="en-GB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GB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1A9C52-AE0C-4789-8B45-CF074FC7CB1E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251216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385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543"/>
            </a:lvl1pPr>
            <a:lvl2pPr marL="293865" indent="0" algn="ctr">
              <a:buNone/>
              <a:defRPr sz="1286"/>
            </a:lvl2pPr>
            <a:lvl3pPr marL="587731" indent="0" algn="ctr">
              <a:buNone/>
              <a:defRPr sz="1157"/>
            </a:lvl3pPr>
            <a:lvl4pPr marL="881596" indent="0" algn="ctr">
              <a:buNone/>
              <a:defRPr sz="1028"/>
            </a:lvl4pPr>
            <a:lvl5pPr marL="1175461" indent="0" algn="ctr">
              <a:buNone/>
              <a:defRPr sz="1028"/>
            </a:lvl5pPr>
            <a:lvl6pPr marL="1469327" indent="0" algn="ctr">
              <a:buNone/>
              <a:defRPr sz="1028"/>
            </a:lvl6pPr>
            <a:lvl7pPr marL="1763192" indent="0" algn="ctr">
              <a:buNone/>
              <a:defRPr sz="1028"/>
            </a:lvl7pPr>
            <a:lvl8pPr marL="2057057" indent="0" algn="ctr">
              <a:buNone/>
              <a:defRPr sz="1028"/>
            </a:lvl8pPr>
            <a:lvl9pPr marL="2350922" indent="0" algn="ctr">
              <a:buNone/>
              <a:defRPr sz="1028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65283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50397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33446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525983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40"/>
            <a:ext cx="10515600" cy="2852737"/>
          </a:xfrm>
        </p:spPr>
        <p:txBody>
          <a:bodyPr anchor="b"/>
          <a:lstStyle>
            <a:lvl1pPr>
              <a:defRPr sz="385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5"/>
            <a:ext cx="10515600" cy="1500187"/>
          </a:xfrm>
        </p:spPr>
        <p:txBody>
          <a:bodyPr/>
          <a:lstStyle>
            <a:lvl1pPr marL="0" indent="0">
              <a:buNone/>
              <a:defRPr sz="1543">
                <a:solidFill>
                  <a:schemeClr val="tx1"/>
                </a:solidFill>
              </a:defRPr>
            </a:lvl1pPr>
            <a:lvl2pPr marL="293865" indent="0">
              <a:buNone/>
              <a:defRPr sz="1286">
                <a:solidFill>
                  <a:schemeClr val="tx1">
                    <a:tint val="75000"/>
                  </a:schemeClr>
                </a:solidFill>
              </a:defRPr>
            </a:lvl2pPr>
            <a:lvl3pPr marL="587731" indent="0">
              <a:buNone/>
              <a:defRPr sz="1157">
                <a:solidFill>
                  <a:schemeClr val="tx1">
                    <a:tint val="75000"/>
                  </a:schemeClr>
                </a:solidFill>
              </a:defRPr>
            </a:lvl3pPr>
            <a:lvl4pPr marL="881596" indent="0">
              <a:buNone/>
              <a:defRPr sz="1028">
                <a:solidFill>
                  <a:schemeClr val="tx1">
                    <a:tint val="75000"/>
                  </a:schemeClr>
                </a:solidFill>
              </a:defRPr>
            </a:lvl4pPr>
            <a:lvl5pPr marL="1175461" indent="0">
              <a:buNone/>
              <a:defRPr sz="1028">
                <a:solidFill>
                  <a:schemeClr val="tx1">
                    <a:tint val="75000"/>
                  </a:schemeClr>
                </a:solidFill>
              </a:defRPr>
            </a:lvl5pPr>
            <a:lvl6pPr marL="1469327" indent="0">
              <a:buNone/>
              <a:defRPr sz="1028">
                <a:solidFill>
                  <a:schemeClr val="tx1">
                    <a:tint val="75000"/>
                  </a:schemeClr>
                </a:solidFill>
              </a:defRPr>
            </a:lvl6pPr>
            <a:lvl7pPr marL="1763192" indent="0">
              <a:buNone/>
              <a:defRPr sz="1028">
                <a:solidFill>
                  <a:schemeClr val="tx1">
                    <a:tint val="75000"/>
                  </a:schemeClr>
                </a:solidFill>
              </a:defRPr>
            </a:lvl7pPr>
            <a:lvl8pPr marL="2057057" indent="0">
              <a:buNone/>
              <a:defRPr sz="1028">
                <a:solidFill>
                  <a:schemeClr val="tx1">
                    <a:tint val="75000"/>
                  </a:schemeClr>
                </a:solidFill>
              </a:defRPr>
            </a:lvl8pPr>
            <a:lvl9pPr marL="2350922" indent="0">
              <a:buNone/>
              <a:defRPr sz="10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33921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36578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543" b="1"/>
            </a:lvl1pPr>
            <a:lvl2pPr marL="293865" indent="0">
              <a:buNone/>
              <a:defRPr sz="1286" b="1"/>
            </a:lvl2pPr>
            <a:lvl3pPr marL="587731" indent="0">
              <a:buNone/>
              <a:defRPr sz="1157" b="1"/>
            </a:lvl3pPr>
            <a:lvl4pPr marL="881596" indent="0">
              <a:buNone/>
              <a:defRPr sz="1028" b="1"/>
            </a:lvl4pPr>
            <a:lvl5pPr marL="1175461" indent="0">
              <a:buNone/>
              <a:defRPr sz="1028" b="1"/>
            </a:lvl5pPr>
            <a:lvl6pPr marL="1469327" indent="0">
              <a:buNone/>
              <a:defRPr sz="1028" b="1"/>
            </a:lvl6pPr>
            <a:lvl7pPr marL="1763192" indent="0">
              <a:buNone/>
              <a:defRPr sz="1028" b="1"/>
            </a:lvl7pPr>
            <a:lvl8pPr marL="2057057" indent="0">
              <a:buNone/>
              <a:defRPr sz="1028" b="1"/>
            </a:lvl8pPr>
            <a:lvl9pPr marL="2350922" indent="0">
              <a:buNone/>
              <a:defRPr sz="102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1543" b="1"/>
            </a:lvl1pPr>
            <a:lvl2pPr marL="293865" indent="0">
              <a:buNone/>
              <a:defRPr sz="1286" b="1"/>
            </a:lvl2pPr>
            <a:lvl3pPr marL="587731" indent="0">
              <a:buNone/>
              <a:defRPr sz="1157" b="1"/>
            </a:lvl3pPr>
            <a:lvl4pPr marL="881596" indent="0">
              <a:buNone/>
              <a:defRPr sz="1028" b="1"/>
            </a:lvl4pPr>
            <a:lvl5pPr marL="1175461" indent="0">
              <a:buNone/>
              <a:defRPr sz="1028" b="1"/>
            </a:lvl5pPr>
            <a:lvl6pPr marL="1469327" indent="0">
              <a:buNone/>
              <a:defRPr sz="1028" b="1"/>
            </a:lvl6pPr>
            <a:lvl7pPr marL="1763192" indent="0">
              <a:buNone/>
              <a:defRPr sz="1028" b="1"/>
            </a:lvl7pPr>
            <a:lvl8pPr marL="2057057" indent="0">
              <a:buNone/>
              <a:defRPr sz="1028" b="1"/>
            </a:lvl8pPr>
            <a:lvl9pPr marL="2350922" indent="0">
              <a:buNone/>
              <a:defRPr sz="102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06915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81623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53926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1"/>
            <a:ext cx="3932238" cy="1600200"/>
          </a:xfrm>
        </p:spPr>
        <p:txBody>
          <a:bodyPr anchor="b"/>
          <a:lstStyle>
            <a:lvl1pPr>
              <a:defRPr sz="205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>
              <a:defRPr sz="2057"/>
            </a:lvl1pPr>
            <a:lvl2pPr>
              <a:defRPr sz="1800"/>
            </a:lvl2pPr>
            <a:lvl3pPr>
              <a:defRPr sz="1543"/>
            </a:lvl3pPr>
            <a:lvl4pPr>
              <a:defRPr sz="1286"/>
            </a:lvl4pPr>
            <a:lvl5pPr>
              <a:defRPr sz="1286"/>
            </a:lvl5pPr>
            <a:lvl6pPr>
              <a:defRPr sz="1286"/>
            </a:lvl6pPr>
            <a:lvl7pPr>
              <a:defRPr sz="1286"/>
            </a:lvl7pPr>
            <a:lvl8pPr>
              <a:defRPr sz="1286"/>
            </a:lvl8pPr>
            <a:lvl9pPr>
              <a:defRPr sz="128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1"/>
            <a:ext cx="3932238" cy="3811588"/>
          </a:xfrm>
        </p:spPr>
        <p:txBody>
          <a:bodyPr/>
          <a:lstStyle>
            <a:lvl1pPr marL="0" indent="0">
              <a:buNone/>
              <a:defRPr sz="1028"/>
            </a:lvl1pPr>
            <a:lvl2pPr marL="293865" indent="0">
              <a:buNone/>
              <a:defRPr sz="900"/>
            </a:lvl2pPr>
            <a:lvl3pPr marL="587731" indent="0">
              <a:buNone/>
              <a:defRPr sz="771"/>
            </a:lvl3pPr>
            <a:lvl4pPr marL="881596" indent="0">
              <a:buNone/>
              <a:defRPr sz="643"/>
            </a:lvl4pPr>
            <a:lvl5pPr marL="1175461" indent="0">
              <a:buNone/>
              <a:defRPr sz="643"/>
            </a:lvl5pPr>
            <a:lvl6pPr marL="1469327" indent="0">
              <a:buNone/>
              <a:defRPr sz="643"/>
            </a:lvl6pPr>
            <a:lvl7pPr marL="1763192" indent="0">
              <a:buNone/>
              <a:defRPr sz="643"/>
            </a:lvl7pPr>
            <a:lvl8pPr marL="2057057" indent="0">
              <a:buNone/>
              <a:defRPr sz="643"/>
            </a:lvl8pPr>
            <a:lvl9pPr marL="2350922" indent="0">
              <a:buNone/>
              <a:defRPr sz="64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7095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1"/>
            <a:ext cx="3932238" cy="1600200"/>
          </a:xfrm>
        </p:spPr>
        <p:txBody>
          <a:bodyPr anchor="b"/>
          <a:lstStyle>
            <a:lvl1pPr>
              <a:defRPr sz="205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6"/>
            <a:ext cx="6172201" cy="4873625"/>
          </a:xfrm>
        </p:spPr>
        <p:txBody>
          <a:bodyPr anchor="t"/>
          <a:lstStyle>
            <a:lvl1pPr marL="0" indent="0">
              <a:buNone/>
              <a:defRPr sz="2057"/>
            </a:lvl1pPr>
            <a:lvl2pPr marL="293865" indent="0">
              <a:buNone/>
              <a:defRPr sz="1800"/>
            </a:lvl2pPr>
            <a:lvl3pPr marL="587731" indent="0">
              <a:buNone/>
              <a:defRPr sz="1543"/>
            </a:lvl3pPr>
            <a:lvl4pPr marL="881596" indent="0">
              <a:buNone/>
              <a:defRPr sz="1286"/>
            </a:lvl4pPr>
            <a:lvl5pPr marL="1175461" indent="0">
              <a:buNone/>
              <a:defRPr sz="1286"/>
            </a:lvl5pPr>
            <a:lvl6pPr marL="1469327" indent="0">
              <a:buNone/>
              <a:defRPr sz="1286"/>
            </a:lvl6pPr>
            <a:lvl7pPr marL="1763192" indent="0">
              <a:buNone/>
              <a:defRPr sz="1286"/>
            </a:lvl7pPr>
            <a:lvl8pPr marL="2057057" indent="0">
              <a:buNone/>
              <a:defRPr sz="1286"/>
            </a:lvl8pPr>
            <a:lvl9pPr marL="2350922" indent="0">
              <a:buNone/>
              <a:defRPr sz="1286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1"/>
            <a:ext cx="3932238" cy="3811588"/>
          </a:xfrm>
        </p:spPr>
        <p:txBody>
          <a:bodyPr/>
          <a:lstStyle>
            <a:lvl1pPr marL="0" indent="0">
              <a:buNone/>
              <a:defRPr sz="1028"/>
            </a:lvl1pPr>
            <a:lvl2pPr marL="293865" indent="0">
              <a:buNone/>
              <a:defRPr sz="900"/>
            </a:lvl2pPr>
            <a:lvl3pPr marL="587731" indent="0">
              <a:buNone/>
              <a:defRPr sz="771"/>
            </a:lvl3pPr>
            <a:lvl4pPr marL="881596" indent="0">
              <a:buNone/>
              <a:defRPr sz="643"/>
            </a:lvl4pPr>
            <a:lvl5pPr marL="1175461" indent="0">
              <a:buNone/>
              <a:defRPr sz="643"/>
            </a:lvl5pPr>
            <a:lvl6pPr marL="1469327" indent="0">
              <a:buNone/>
              <a:defRPr sz="643"/>
            </a:lvl6pPr>
            <a:lvl7pPr marL="1763192" indent="0">
              <a:buNone/>
              <a:defRPr sz="643"/>
            </a:lvl7pPr>
            <a:lvl8pPr marL="2057057" indent="0">
              <a:buNone/>
              <a:defRPr sz="643"/>
            </a:lvl8pPr>
            <a:lvl9pPr marL="2350922" indent="0">
              <a:buNone/>
              <a:defRPr sz="64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51662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B52DC-044A-4ECD-88B7-1783FD8D7B4B}" type="datetimeFigureOut">
              <a:rPr kumimoji="1" lang="ja-JP" altLang="en-US" smtClean="0"/>
              <a:t>2017/9/1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F1174-38B5-48ED-9894-F93C6C9B6C0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90523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87731" rtl="0" eaLnBrk="1" latinLnBrk="0" hangingPunct="1">
        <a:lnSpc>
          <a:spcPct val="90000"/>
        </a:lnSpc>
        <a:spcBef>
          <a:spcPct val="0"/>
        </a:spcBef>
        <a:buNone/>
        <a:defRPr sz="282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6933" indent="-146933" algn="l" defTabSz="587731" rtl="0" eaLnBrk="1" latinLnBrk="0" hangingPunct="1">
        <a:lnSpc>
          <a:spcPct val="90000"/>
        </a:lnSpc>
        <a:spcBef>
          <a:spcPts val="643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40798" indent="-146933" algn="l" defTabSz="587731" rtl="0" eaLnBrk="1" latinLnBrk="0" hangingPunct="1">
        <a:lnSpc>
          <a:spcPct val="90000"/>
        </a:lnSpc>
        <a:spcBef>
          <a:spcPts val="321"/>
        </a:spcBef>
        <a:buFont typeface="Arial" panose="020B0604020202020204" pitchFamily="34" charset="0"/>
        <a:buChar char="•"/>
        <a:defRPr sz="1543" kern="1200">
          <a:solidFill>
            <a:schemeClr val="tx1"/>
          </a:solidFill>
          <a:latin typeface="+mn-lt"/>
          <a:ea typeface="+mn-ea"/>
          <a:cs typeface="+mn-cs"/>
        </a:defRPr>
      </a:lvl2pPr>
      <a:lvl3pPr marL="734663" indent="-146933" algn="l" defTabSz="587731" rtl="0" eaLnBrk="1" latinLnBrk="0" hangingPunct="1">
        <a:lnSpc>
          <a:spcPct val="90000"/>
        </a:lnSpc>
        <a:spcBef>
          <a:spcPts val="321"/>
        </a:spcBef>
        <a:buFont typeface="Arial" panose="020B0604020202020204" pitchFamily="34" charset="0"/>
        <a:buChar char="•"/>
        <a:defRPr sz="1286" kern="1200">
          <a:solidFill>
            <a:schemeClr val="tx1"/>
          </a:solidFill>
          <a:latin typeface="+mn-lt"/>
          <a:ea typeface="+mn-ea"/>
          <a:cs typeface="+mn-cs"/>
        </a:defRPr>
      </a:lvl3pPr>
      <a:lvl4pPr marL="1028529" indent="-146933" algn="l" defTabSz="587731" rtl="0" eaLnBrk="1" latinLnBrk="0" hangingPunct="1">
        <a:lnSpc>
          <a:spcPct val="90000"/>
        </a:lnSpc>
        <a:spcBef>
          <a:spcPts val="321"/>
        </a:spcBef>
        <a:buFont typeface="Arial" panose="020B0604020202020204" pitchFamily="34" charset="0"/>
        <a:buChar char="•"/>
        <a:defRPr sz="1157" kern="1200">
          <a:solidFill>
            <a:schemeClr val="tx1"/>
          </a:solidFill>
          <a:latin typeface="+mn-lt"/>
          <a:ea typeface="+mn-ea"/>
          <a:cs typeface="+mn-cs"/>
        </a:defRPr>
      </a:lvl4pPr>
      <a:lvl5pPr marL="1322394" indent="-146933" algn="l" defTabSz="587731" rtl="0" eaLnBrk="1" latinLnBrk="0" hangingPunct="1">
        <a:lnSpc>
          <a:spcPct val="90000"/>
        </a:lnSpc>
        <a:spcBef>
          <a:spcPts val="321"/>
        </a:spcBef>
        <a:buFont typeface="Arial" panose="020B0604020202020204" pitchFamily="34" charset="0"/>
        <a:buChar char="•"/>
        <a:defRPr sz="1157" kern="1200">
          <a:solidFill>
            <a:schemeClr val="tx1"/>
          </a:solidFill>
          <a:latin typeface="+mn-lt"/>
          <a:ea typeface="+mn-ea"/>
          <a:cs typeface="+mn-cs"/>
        </a:defRPr>
      </a:lvl5pPr>
      <a:lvl6pPr marL="1616259" indent="-146933" algn="l" defTabSz="587731" rtl="0" eaLnBrk="1" latinLnBrk="0" hangingPunct="1">
        <a:lnSpc>
          <a:spcPct val="90000"/>
        </a:lnSpc>
        <a:spcBef>
          <a:spcPts val="321"/>
        </a:spcBef>
        <a:buFont typeface="Arial" panose="020B0604020202020204" pitchFamily="34" charset="0"/>
        <a:buChar char="•"/>
        <a:defRPr sz="1157" kern="1200">
          <a:solidFill>
            <a:schemeClr val="tx1"/>
          </a:solidFill>
          <a:latin typeface="+mn-lt"/>
          <a:ea typeface="+mn-ea"/>
          <a:cs typeface="+mn-cs"/>
        </a:defRPr>
      </a:lvl6pPr>
      <a:lvl7pPr marL="1910124" indent="-146933" algn="l" defTabSz="587731" rtl="0" eaLnBrk="1" latinLnBrk="0" hangingPunct="1">
        <a:lnSpc>
          <a:spcPct val="90000"/>
        </a:lnSpc>
        <a:spcBef>
          <a:spcPts val="321"/>
        </a:spcBef>
        <a:buFont typeface="Arial" panose="020B0604020202020204" pitchFamily="34" charset="0"/>
        <a:buChar char="•"/>
        <a:defRPr sz="1157" kern="1200">
          <a:solidFill>
            <a:schemeClr val="tx1"/>
          </a:solidFill>
          <a:latin typeface="+mn-lt"/>
          <a:ea typeface="+mn-ea"/>
          <a:cs typeface="+mn-cs"/>
        </a:defRPr>
      </a:lvl7pPr>
      <a:lvl8pPr marL="2203990" indent="-146933" algn="l" defTabSz="587731" rtl="0" eaLnBrk="1" latinLnBrk="0" hangingPunct="1">
        <a:lnSpc>
          <a:spcPct val="90000"/>
        </a:lnSpc>
        <a:spcBef>
          <a:spcPts val="321"/>
        </a:spcBef>
        <a:buFont typeface="Arial" panose="020B0604020202020204" pitchFamily="34" charset="0"/>
        <a:buChar char="•"/>
        <a:defRPr sz="1157" kern="1200">
          <a:solidFill>
            <a:schemeClr val="tx1"/>
          </a:solidFill>
          <a:latin typeface="+mn-lt"/>
          <a:ea typeface="+mn-ea"/>
          <a:cs typeface="+mn-cs"/>
        </a:defRPr>
      </a:lvl8pPr>
      <a:lvl9pPr marL="2497855" indent="-146933" algn="l" defTabSz="587731" rtl="0" eaLnBrk="1" latinLnBrk="0" hangingPunct="1">
        <a:lnSpc>
          <a:spcPct val="90000"/>
        </a:lnSpc>
        <a:spcBef>
          <a:spcPts val="321"/>
        </a:spcBef>
        <a:buFont typeface="Arial" panose="020B0604020202020204" pitchFamily="34" charset="0"/>
        <a:buChar char="•"/>
        <a:defRPr sz="115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87731" rtl="0" eaLnBrk="1" latinLnBrk="0" hangingPunct="1">
        <a:defRPr sz="1157" kern="1200">
          <a:solidFill>
            <a:schemeClr val="tx1"/>
          </a:solidFill>
          <a:latin typeface="+mn-lt"/>
          <a:ea typeface="+mn-ea"/>
          <a:cs typeface="+mn-cs"/>
        </a:defRPr>
      </a:lvl1pPr>
      <a:lvl2pPr marL="293865" algn="l" defTabSz="587731" rtl="0" eaLnBrk="1" latinLnBrk="0" hangingPunct="1">
        <a:defRPr sz="1157" kern="1200">
          <a:solidFill>
            <a:schemeClr val="tx1"/>
          </a:solidFill>
          <a:latin typeface="+mn-lt"/>
          <a:ea typeface="+mn-ea"/>
          <a:cs typeface="+mn-cs"/>
        </a:defRPr>
      </a:lvl2pPr>
      <a:lvl3pPr marL="587731" algn="l" defTabSz="587731" rtl="0" eaLnBrk="1" latinLnBrk="0" hangingPunct="1">
        <a:defRPr sz="1157" kern="1200">
          <a:solidFill>
            <a:schemeClr val="tx1"/>
          </a:solidFill>
          <a:latin typeface="+mn-lt"/>
          <a:ea typeface="+mn-ea"/>
          <a:cs typeface="+mn-cs"/>
        </a:defRPr>
      </a:lvl3pPr>
      <a:lvl4pPr marL="881596" algn="l" defTabSz="587731" rtl="0" eaLnBrk="1" latinLnBrk="0" hangingPunct="1">
        <a:defRPr sz="1157" kern="1200">
          <a:solidFill>
            <a:schemeClr val="tx1"/>
          </a:solidFill>
          <a:latin typeface="+mn-lt"/>
          <a:ea typeface="+mn-ea"/>
          <a:cs typeface="+mn-cs"/>
        </a:defRPr>
      </a:lvl4pPr>
      <a:lvl5pPr marL="1175461" algn="l" defTabSz="587731" rtl="0" eaLnBrk="1" latinLnBrk="0" hangingPunct="1">
        <a:defRPr sz="1157" kern="1200">
          <a:solidFill>
            <a:schemeClr val="tx1"/>
          </a:solidFill>
          <a:latin typeface="+mn-lt"/>
          <a:ea typeface="+mn-ea"/>
          <a:cs typeface="+mn-cs"/>
        </a:defRPr>
      </a:lvl5pPr>
      <a:lvl6pPr marL="1469327" algn="l" defTabSz="587731" rtl="0" eaLnBrk="1" latinLnBrk="0" hangingPunct="1">
        <a:defRPr sz="1157" kern="1200">
          <a:solidFill>
            <a:schemeClr val="tx1"/>
          </a:solidFill>
          <a:latin typeface="+mn-lt"/>
          <a:ea typeface="+mn-ea"/>
          <a:cs typeface="+mn-cs"/>
        </a:defRPr>
      </a:lvl6pPr>
      <a:lvl7pPr marL="1763192" algn="l" defTabSz="587731" rtl="0" eaLnBrk="1" latinLnBrk="0" hangingPunct="1">
        <a:defRPr sz="1157" kern="1200">
          <a:solidFill>
            <a:schemeClr val="tx1"/>
          </a:solidFill>
          <a:latin typeface="+mn-lt"/>
          <a:ea typeface="+mn-ea"/>
          <a:cs typeface="+mn-cs"/>
        </a:defRPr>
      </a:lvl7pPr>
      <a:lvl8pPr marL="2057057" algn="l" defTabSz="587731" rtl="0" eaLnBrk="1" latinLnBrk="0" hangingPunct="1">
        <a:defRPr sz="1157" kern="1200">
          <a:solidFill>
            <a:schemeClr val="tx1"/>
          </a:solidFill>
          <a:latin typeface="+mn-lt"/>
          <a:ea typeface="+mn-ea"/>
          <a:cs typeface="+mn-cs"/>
        </a:defRPr>
      </a:lvl8pPr>
      <a:lvl9pPr marL="2350922" algn="l" defTabSz="587731" rtl="0" eaLnBrk="1" latinLnBrk="0" hangingPunct="1">
        <a:defRPr sz="115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4213145" y="1660922"/>
            <a:ext cx="3918080" cy="4089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783641"/>
            <a:r>
              <a:rPr lang="en-GB" altLang="ja-JP" sz="686" b="1" kern="100" dirty="0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S1. P</a:t>
            </a:r>
            <a:r>
              <a:rPr lang="en-US" altLang="ja-JP" sz="686" b="1" kern="100" dirty="0" err="1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olymorphic</a:t>
            </a:r>
            <a:r>
              <a:rPr lang="en-US" altLang="ja-JP" sz="686" b="1" kern="100" dirty="0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 sites of the mtDNA control region detected in Japanese </a:t>
            </a:r>
            <a:r>
              <a:rPr lang="en-US" altLang="ja-JP" sz="686" b="1" kern="100" dirty="0" err="1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harbour</a:t>
            </a:r>
            <a:r>
              <a:rPr lang="en-US" altLang="ja-JP" sz="686" b="1" kern="100" dirty="0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 seals of Hokkaido. </a:t>
            </a:r>
            <a:r>
              <a:rPr lang="en-US" altLang="ja-JP" sz="686" kern="100" dirty="0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A total of 16 haplotypes were detected. Position of the variable sites are indicated on the top with reference to </a:t>
            </a:r>
            <a:r>
              <a:rPr lang="en-US" altLang="ja-JP" sz="686" kern="100" dirty="0" err="1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Arnason</a:t>
            </a:r>
            <a:r>
              <a:rPr lang="en-US" altLang="ja-JP" sz="686" kern="100" dirty="0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 and </a:t>
            </a:r>
            <a:r>
              <a:rPr lang="en-US" altLang="ja-JP" sz="686" kern="100" dirty="0" err="1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Johnsson</a:t>
            </a:r>
            <a:r>
              <a:rPr lang="en-US" altLang="ja-JP" sz="686" kern="100" dirty="0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 (1992). All haplotypes are registered to </a:t>
            </a:r>
            <a:r>
              <a:rPr lang="en-US" altLang="ja-JP" sz="686" kern="100" dirty="0" err="1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GenBank</a:t>
            </a:r>
            <a:r>
              <a:rPr lang="en-US" altLang="ja-JP" sz="686" kern="100" dirty="0">
                <a:solidFill>
                  <a:prstClr val="black"/>
                </a:solidFill>
                <a:latin typeface="Calibri" panose="020F0502020204030204"/>
                <a:ea typeface="ＭＳ 明朝" panose="02020609040205080304" pitchFamily="17" charset="-128"/>
                <a:cs typeface="Times New Roman" panose="02020603050405020304" pitchFamily="18" charset="0"/>
              </a:rPr>
              <a:t> (LC314221-LC314236).</a:t>
            </a:r>
            <a:endParaRPr lang="ja-JP" altLang="ja-JP" sz="686" kern="100" dirty="0">
              <a:solidFill>
                <a:prstClr val="black"/>
              </a:solidFill>
              <a:latin typeface="Calibri" panose="020F0502020204030204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5" name="オブジェクト 4"/>
          <p:cNvGraphicFramePr>
            <a:graphicFrameLocks noChangeAspect="1"/>
          </p:cNvGraphicFramePr>
          <p:nvPr>
            <p:extLst/>
          </p:nvPr>
        </p:nvGraphicFramePr>
        <p:xfrm>
          <a:off x="4195460" y="2100526"/>
          <a:ext cx="3996986" cy="33562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Worksheet" r:id="rId3" imgW="4663359" imgH="3916728" progId="Excel.Sheet.8">
                  <p:embed/>
                </p:oleObj>
              </mc:Choice>
              <mc:Fallback>
                <p:oleObj name="Worksheet" r:id="rId3" imgW="4663359" imgH="3916728" progId="Excel.Sheet.8">
                  <p:embed/>
                  <p:pic>
                    <p:nvPicPr>
                      <p:cNvPr id="5" name="オブジェクト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95460" y="2100526"/>
                        <a:ext cx="3996986" cy="33562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0871703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47</TotalTime>
  <Words>54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ＭＳ 明朝</vt:lpstr>
      <vt:lpstr>Arial</vt:lpstr>
      <vt:lpstr>Calibri</vt:lpstr>
      <vt:lpstr>Calibri Light</vt:lpstr>
      <vt:lpstr>Times New Roman</vt:lpstr>
      <vt:lpstr>1_Office テーマ</vt:lpstr>
      <vt:lpstr>Worksheet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riko m</dc:creator>
  <cp:lastModifiedBy>m m</cp:lastModifiedBy>
  <cp:revision>323</cp:revision>
  <cp:lastPrinted>2016-09-16T23:34:19Z</cp:lastPrinted>
  <dcterms:created xsi:type="dcterms:W3CDTF">2015-11-27T03:49:49Z</dcterms:created>
  <dcterms:modified xsi:type="dcterms:W3CDTF">2017-09-10T08:34:31Z</dcterms:modified>
</cp:coreProperties>
</file>